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840" y="14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6119F6-6829-4352-9C35-918AF77EDA12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6DB077-615F-4F2F-A6B0-F54C7DB246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3311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476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64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632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07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6944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95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6484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8092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395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859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8814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173EC-5A7E-4BFF-974E-9D39B470D58C}" type="datetimeFigureOut">
              <a:rPr kumimoji="1" lang="ja-JP" altLang="en-US" smtClean="0"/>
              <a:t>2015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9A07C-3132-4C5A-9132-84C591AA4A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081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512861"/>
            <a:ext cx="6040365" cy="5448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5" name="テキスト ボックス 74"/>
          <p:cNvSpPr txBox="1"/>
          <p:nvPr/>
        </p:nvSpPr>
        <p:spPr>
          <a:xfrm>
            <a:off x="476673" y="6498267"/>
            <a:ext cx="590465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tic protocol for PAA-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OxNP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mation from TiO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s. DMF =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methylformamide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EPES = 4-(2-hydroxyethyl)-1-piperazineethanesulfonic acid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513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3</TotalTime>
  <Words>25</Words>
  <Application>Microsoft Office PowerPoint</Application>
  <PresentationFormat>A4 210 x 297 mm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</dc:creator>
  <cp:lastModifiedBy>Naka</cp:lastModifiedBy>
  <cp:revision>92</cp:revision>
  <cp:lastPrinted>2015-08-25T10:37:58Z</cp:lastPrinted>
  <dcterms:created xsi:type="dcterms:W3CDTF">2015-05-29T09:59:46Z</dcterms:created>
  <dcterms:modified xsi:type="dcterms:W3CDTF">2015-12-03T02:41:20Z</dcterms:modified>
</cp:coreProperties>
</file>